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1" r:id="rId2"/>
    <p:sldId id="263" r:id="rId3"/>
    <p:sldId id="272" r:id="rId4"/>
    <p:sldId id="273" r:id="rId5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44" userDrawn="1">
          <p15:clr>
            <a:srgbClr val="A4A3A4"/>
          </p15:clr>
        </p15:guide>
        <p15:guide id="2" pos="1511" userDrawn="1">
          <p15:clr>
            <a:srgbClr val="A4A3A4"/>
          </p15:clr>
        </p15:guide>
        <p15:guide id="3" orient="horz" pos="4662" userDrawn="1">
          <p15:clr>
            <a:srgbClr val="A4A3A4"/>
          </p15:clr>
        </p15:guide>
        <p15:guide id="4" pos="9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sper Vestlund" initials="JV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D3A02C-A6AB-4CD7-BE19-30093E212ABC}" v="5" dt="2021-12-13T15:42:40.5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>
    <p:restoredLeft sz="10299" autoAdjust="0"/>
    <p:restoredTop sz="86391"/>
  </p:normalViewPr>
  <p:slideViewPr>
    <p:cSldViewPr snapToGrid="0">
      <p:cViewPr>
        <p:scale>
          <a:sx n="90" d="100"/>
          <a:sy n="90" d="100"/>
        </p:scale>
        <p:origin x="2405" y="53"/>
      </p:cViewPr>
      <p:guideLst>
        <p:guide orient="horz" pos="1844"/>
        <p:guide pos="1511"/>
        <p:guide orient="horz" pos="4662"/>
        <p:guide pos="9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lesya Shevchouk" userId="00f0f073-86fa-4197-bbeb-d4bc62fbc364" providerId="ADAL" clId="{33D3A02C-A6AB-4CD7-BE19-30093E212ABC}"/>
    <pc:docChg chg="undo custSel modSld">
      <pc:chgData name="Olesya Shevchouk" userId="00f0f073-86fa-4197-bbeb-d4bc62fbc364" providerId="ADAL" clId="{33D3A02C-A6AB-4CD7-BE19-30093E212ABC}" dt="2021-12-13T15:43:30.196" v="143" actId="20577"/>
      <pc:docMkLst>
        <pc:docMk/>
      </pc:docMkLst>
      <pc:sldChg chg="addSp delSp modSp mod">
        <pc:chgData name="Olesya Shevchouk" userId="00f0f073-86fa-4197-bbeb-d4bc62fbc364" providerId="ADAL" clId="{33D3A02C-A6AB-4CD7-BE19-30093E212ABC}" dt="2021-12-13T15:43:30.196" v="143" actId="20577"/>
        <pc:sldMkLst>
          <pc:docMk/>
          <pc:sldMk cId="552432272" sldId="273"/>
        </pc:sldMkLst>
        <pc:spChg chg="mod">
          <ac:chgData name="Olesya Shevchouk" userId="00f0f073-86fa-4197-bbeb-d4bc62fbc364" providerId="ADAL" clId="{33D3A02C-A6AB-4CD7-BE19-30093E212ABC}" dt="2021-12-13T15:43:30.196" v="143" actId="20577"/>
          <ac:spMkLst>
            <pc:docMk/>
            <pc:sldMk cId="552432272" sldId="273"/>
            <ac:spMk id="6" creationId="{E1B618B5-2541-4359-A94C-3040D317F408}"/>
          </ac:spMkLst>
        </pc:spChg>
        <pc:graphicFrameChg chg="add del mod">
          <ac:chgData name="Olesya Shevchouk" userId="00f0f073-86fa-4197-bbeb-d4bc62fbc364" providerId="ADAL" clId="{33D3A02C-A6AB-4CD7-BE19-30093E212ABC}" dt="2021-12-13T15:41:37.041" v="8"/>
          <ac:graphicFrameMkLst>
            <pc:docMk/>
            <pc:sldMk cId="552432272" sldId="273"/>
            <ac:graphicFrameMk id="2" creationId="{3CE7A430-B547-411D-A629-DCF4B04FA5C2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8A956B-CD91-4F65-B15D-54823742F93E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6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9CD383-EF32-4E27-9D0B-CE0CBE274F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1718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9CD383-EF32-4E27-9D0B-CE0CBE274FD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24625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9CD383-EF32-4E27-9D0B-CE0CBE274FDD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55565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9CD383-EF32-4E27-9D0B-CE0CBE274FDD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4226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73805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27966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3491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39127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54837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86248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38673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23892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96738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47521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17834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2CEDF-A7E1-4BB9-A2E1-FEF964AE7B2A}" type="datetimeFigureOut">
              <a:rPr lang="sv-SE" smtClean="0"/>
              <a:t>2022-04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93C50-D1FB-4DD1-8C47-B237E17922E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82715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>
            <a:extLst>
              <a:ext uri="{FF2B5EF4-FFF2-40B4-BE49-F238E27FC236}">
                <a16:creationId xmlns:a16="http://schemas.microsoft.com/office/drawing/2014/main" id="{50FD1990-0D8B-D04F-A070-6DAF4447FDDB}"/>
              </a:ext>
            </a:extLst>
          </p:cNvPr>
          <p:cNvSpPr txBox="1"/>
          <p:nvPr/>
        </p:nvSpPr>
        <p:spPr>
          <a:xfrm>
            <a:off x="47217" y="-258"/>
            <a:ext cx="5615640" cy="6401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Supplementary figure 1</a:t>
            </a:r>
          </a:p>
          <a:p>
            <a:r>
              <a:rPr lang="en-US" sz="1200" b="1" dirty="0">
                <a:cs typeface="Arial" panose="020B0604020202020204" pitchFamily="34" charset="0"/>
              </a:rPr>
              <a:t>        </a:t>
            </a:r>
            <a:r>
              <a:rPr lang="en-US" sz="1000" b="1" dirty="0">
                <a:cs typeface="Arial" panose="020B0604020202020204" pitchFamily="34" charset="0"/>
              </a:rPr>
              <a:t>Panel A. Schematic illustration of the resident intruder experiment, repeated treatment with Ex4</a:t>
            </a: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r>
              <a:rPr lang="en-US" sz="1200" b="1" dirty="0">
                <a:cs typeface="Arial" panose="020B0604020202020204" pitchFamily="34" charset="0"/>
              </a:rPr>
              <a:t>        </a:t>
            </a:r>
            <a:r>
              <a:rPr lang="en-US" sz="1000" b="1" dirty="0">
                <a:cs typeface="Arial" panose="020B0604020202020204" pitchFamily="34" charset="0"/>
              </a:rPr>
              <a:t>Panel B. Aggressive behaviors, training</a:t>
            </a: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r>
              <a:rPr lang="en-US" sz="1000" b="1" dirty="0">
                <a:cs typeface="Arial" panose="020B0604020202020204" pitchFamily="34" charset="0"/>
              </a:rPr>
              <a:t>        Panel C. Aggressive behaviors, test day</a:t>
            </a: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  <a:p>
            <a:r>
              <a:rPr lang="en-US" sz="1000" b="1" dirty="0">
                <a:cs typeface="Arial" panose="020B0604020202020204" pitchFamily="34" charset="0"/>
              </a:rPr>
              <a:t>        Panel D. Non-aggressive behaviors, test day</a:t>
            </a:r>
          </a:p>
        </p:txBody>
      </p:sp>
      <p:sp>
        <p:nvSpPr>
          <p:cNvPr id="204" name="Rounded Rectangle 203">
            <a:extLst>
              <a:ext uri="{FF2B5EF4-FFF2-40B4-BE49-F238E27FC236}">
                <a16:creationId xmlns:a16="http://schemas.microsoft.com/office/drawing/2014/main" id="{D07A04E4-DE3C-1943-8841-A7058B804106}"/>
              </a:ext>
            </a:extLst>
          </p:cNvPr>
          <p:cNvSpPr/>
          <p:nvPr/>
        </p:nvSpPr>
        <p:spPr>
          <a:xfrm>
            <a:off x="160051" y="3486721"/>
            <a:ext cx="3104518" cy="2460869"/>
          </a:xfrm>
          <a:prstGeom prst="roundRect">
            <a:avLst/>
          </a:prstGeom>
          <a:noFill/>
          <a:ln w="38100"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5" name="Rounded Rectangle 204">
            <a:extLst>
              <a:ext uri="{FF2B5EF4-FFF2-40B4-BE49-F238E27FC236}">
                <a16:creationId xmlns:a16="http://schemas.microsoft.com/office/drawing/2014/main" id="{7AF15C4B-4E46-904A-856B-F0C2D4A08193}"/>
              </a:ext>
            </a:extLst>
          </p:cNvPr>
          <p:cNvSpPr/>
          <p:nvPr/>
        </p:nvSpPr>
        <p:spPr>
          <a:xfrm>
            <a:off x="154218" y="6097868"/>
            <a:ext cx="4023351" cy="1523566"/>
          </a:xfrm>
          <a:prstGeom prst="roundRect">
            <a:avLst/>
          </a:prstGeom>
          <a:noFill/>
          <a:ln w="28575"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CEFD7A94-D0D3-D748-9C33-2D7C664CBD90}"/>
              </a:ext>
            </a:extLst>
          </p:cNvPr>
          <p:cNvSpPr txBox="1"/>
          <p:nvPr/>
        </p:nvSpPr>
        <p:spPr>
          <a:xfrm rot="16200000">
            <a:off x="823846" y="3927556"/>
            <a:ext cx="1118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Attack </a:t>
            </a:r>
          </a:p>
          <a:p>
            <a:r>
              <a:rPr lang="en-US" sz="800">
                <a:cs typeface="Arial" panose="020B0604020202020204" pitchFamily="34" charset="0"/>
              </a:rPr>
              <a:t>frequency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0A431B22-C2A0-1F4C-9DF9-3E389C8CBF11}"/>
              </a:ext>
            </a:extLst>
          </p:cNvPr>
          <p:cNvSpPr txBox="1"/>
          <p:nvPr/>
        </p:nvSpPr>
        <p:spPr>
          <a:xfrm rot="16200000">
            <a:off x="-189007" y="3927556"/>
            <a:ext cx="1118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Attack</a:t>
            </a:r>
          </a:p>
          <a:p>
            <a:r>
              <a:rPr lang="en-US" sz="800" dirty="0">
                <a:cs typeface="Arial" panose="020B0604020202020204" pitchFamily="34" charset="0"/>
              </a:rPr>
              <a:t>duration (sec)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48D564B1-19B7-A24E-9E22-0846D17CEC0F}"/>
              </a:ext>
            </a:extLst>
          </p:cNvPr>
          <p:cNvSpPr txBox="1"/>
          <p:nvPr/>
        </p:nvSpPr>
        <p:spPr>
          <a:xfrm rot="16200000">
            <a:off x="1762193" y="3943529"/>
            <a:ext cx="10863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Attack</a:t>
            </a:r>
          </a:p>
          <a:p>
            <a:r>
              <a:rPr lang="en-US" sz="800">
                <a:cs typeface="Arial" panose="020B0604020202020204" pitchFamily="34" charset="0"/>
              </a:rPr>
              <a:t>latency (sec)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3564B4BD-B175-BC4D-970F-81FEA61B2621}"/>
              </a:ext>
            </a:extLst>
          </p:cNvPr>
          <p:cNvSpPr txBox="1"/>
          <p:nvPr/>
        </p:nvSpPr>
        <p:spPr>
          <a:xfrm rot="16200000">
            <a:off x="-194417" y="5026377"/>
            <a:ext cx="11358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Threat </a:t>
            </a:r>
          </a:p>
          <a:p>
            <a:r>
              <a:rPr lang="en-US" sz="800">
                <a:cs typeface="Arial" panose="020B0604020202020204" pitchFamily="34" charset="0"/>
              </a:rPr>
              <a:t>duration (sec)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C07AFD76-2F2C-5140-93EB-B0DF897E81B2}"/>
              </a:ext>
            </a:extLst>
          </p:cNvPr>
          <p:cNvSpPr txBox="1"/>
          <p:nvPr/>
        </p:nvSpPr>
        <p:spPr>
          <a:xfrm rot="16200000">
            <a:off x="1763879" y="5051138"/>
            <a:ext cx="10863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Threat</a:t>
            </a:r>
          </a:p>
          <a:p>
            <a:r>
              <a:rPr lang="en-US" sz="800">
                <a:cs typeface="Arial" panose="020B0604020202020204" pitchFamily="34" charset="0"/>
              </a:rPr>
              <a:t>latency (sec)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F8218DDB-DF67-C54F-92B2-7FCB97E46CDE}"/>
              </a:ext>
            </a:extLst>
          </p:cNvPr>
          <p:cNvSpPr txBox="1"/>
          <p:nvPr/>
        </p:nvSpPr>
        <p:spPr>
          <a:xfrm rot="16200000">
            <a:off x="892741" y="5106280"/>
            <a:ext cx="9760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Threat </a:t>
            </a:r>
          </a:p>
          <a:p>
            <a:r>
              <a:rPr lang="en-US" sz="800">
                <a:cs typeface="Arial" panose="020B0604020202020204" pitchFamily="34" charset="0"/>
              </a:rPr>
              <a:t>frequency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7F583C9D-3693-F648-A1CF-41BCE730E176}"/>
              </a:ext>
            </a:extLst>
          </p:cNvPr>
          <p:cNvSpPr txBox="1"/>
          <p:nvPr/>
        </p:nvSpPr>
        <p:spPr>
          <a:xfrm rot="16200000">
            <a:off x="-152767" y="6758808"/>
            <a:ext cx="10363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Social behavior </a:t>
            </a:r>
          </a:p>
          <a:p>
            <a:r>
              <a:rPr lang="en-US" sz="800">
                <a:cs typeface="Arial" panose="020B0604020202020204" pitchFamily="34" charset="0"/>
              </a:rPr>
              <a:t>duration (sec)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A8DCC07F-A11B-0D4A-9F83-3BC0D4502752}"/>
              </a:ext>
            </a:extLst>
          </p:cNvPr>
          <p:cNvSpPr txBox="1"/>
          <p:nvPr/>
        </p:nvSpPr>
        <p:spPr>
          <a:xfrm rot="16200000">
            <a:off x="925974" y="6826992"/>
            <a:ext cx="899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Social behavior </a:t>
            </a:r>
          </a:p>
          <a:p>
            <a:r>
              <a:rPr lang="en-US" sz="800">
                <a:cs typeface="Arial" panose="020B0604020202020204" pitchFamily="34" charset="0"/>
              </a:rPr>
              <a:t>frequency 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AB108EF3-5866-2942-BAB5-82F86BA25D3E}"/>
              </a:ext>
            </a:extLst>
          </p:cNvPr>
          <p:cNvSpPr txBox="1"/>
          <p:nvPr/>
        </p:nvSpPr>
        <p:spPr>
          <a:xfrm rot="16200000">
            <a:off x="2686919" y="6669715"/>
            <a:ext cx="12145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on-social behavior </a:t>
            </a:r>
          </a:p>
          <a:p>
            <a:r>
              <a:rPr lang="en-US" sz="800">
                <a:cs typeface="Arial" panose="020B0604020202020204" pitchFamily="34" charset="0"/>
              </a:rPr>
              <a:t>duration (sec)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645F936D-AB6A-EF40-A018-CDA4D5880093}"/>
              </a:ext>
            </a:extLst>
          </p:cNvPr>
          <p:cNvSpPr txBox="1"/>
          <p:nvPr/>
        </p:nvSpPr>
        <p:spPr>
          <a:xfrm rot="16200000">
            <a:off x="1860799" y="6826992"/>
            <a:ext cx="90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Social behavior </a:t>
            </a:r>
          </a:p>
          <a:p>
            <a:r>
              <a:rPr lang="en-US" sz="800">
                <a:cs typeface="Arial" panose="020B0604020202020204" pitchFamily="34" charset="0"/>
              </a:rPr>
              <a:t>latency (sec)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992683A9-DB1C-CF46-818C-3DDB4FFE4ED6}"/>
              </a:ext>
            </a:extLst>
          </p:cNvPr>
          <p:cNvSpPr txBox="1"/>
          <p:nvPr/>
        </p:nvSpPr>
        <p:spPr>
          <a:xfrm>
            <a:off x="578962" y="4650365"/>
            <a:ext cx="28367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  Veh    Ex4                         Veh    Ex4                          Veh    Ex4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2B48B563-B225-D04F-8B4F-8686558A9312}"/>
              </a:ext>
            </a:extLst>
          </p:cNvPr>
          <p:cNvSpPr txBox="1"/>
          <p:nvPr/>
        </p:nvSpPr>
        <p:spPr>
          <a:xfrm>
            <a:off x="870542" y="4115686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2A69941C-CDF8-CC47-A1F2-673BC55A3742}"/>
              </a:ext>
            </a:extLst>
          </p:cNvPr>
          <p:cNvSpPr txBox="1"/>
          <p:nvPr/>
        </p:nvSpPr>
        <p:spPr>
          <a:xfrm>
            <a:off x="569152" y="5726220"/>
            <a:ext cx="31774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  Veh    Ex4                         Veh    Ex4                          Veh    Ex4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9FB8FF3F-BD05-5A48-87AA-CB724D0B85DF}"/>
              </a:ext>
            </a:extLst>
          </p:cNvPr>
          <p:cNvSpPr txBox="1"/>
          <p:nvPr/>
        </p:nvSpPr>
        <p:spPr>
          <a:xfrm>
            <a:off x="1838120" y="4136899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C5599E56-6C6C-C443-96AF-2B0272C2F83A}"/>
              </a:ext>
            </a:extLst>
          </p:cNvPr>
          <p:cNvSpPr txBox="1"/>
          <p:nvPr/>
        </p:nvSpPr>
        <p:spPr>
          <a:xfrm>
            <a:off x="2812226" y="4190470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067A5252-C755-C444-900C-C64F983651C9}"/>
              </a:ext>
            </a:extLst>
          </p:cNvPr>
          <p:cNvSpPr txBox="1"/>
          <p:nvPr/>
        </p:nvSpPr>
        <p:spPr>
          <a:xfrm>
            <a:off x="867897" y="5352629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92D80BD7-AD92-2D4A-B102-51EF49FAB15D}"/>
              </a:ext>
            </a:extLst>
          </p:cNvPr>
          <p:cNvSpPr txBox="1"/>
          <p:nvPr/>
        </p:nvSpPr>
        <p:spPr>
          <a:xfrm>
            <a:off x="1825358" y="5253143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4A446AEC-4FE5-E549-8F4A-C67F5CE12352}"/>
              </a:ext>
            </a:extLst>
          </p:cNvPr>
          <p:cNvSpPr txBox="1"/>
          <p:nvPr/>
        </p:nvSpPr>
        <p:spPr>
          <a:xfrm>
            <a:off x="2824418" y="5158885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890CD233-881E-8E45-84D7-DC56D7A0C2C2}"/>
              </a:ext>
            </a:extLst>
          </p:cNvPr>
          <p:cNvSpPr txBox="1"/>
          <p:nvPr/>
        </p:nvSpPr>
        <p:spPr>
          <a:xfrm>
            <a:off x="569152" y="7405502"/>
            <a:ext cx="3700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  Veh    Ex4                          Veh    Ex4                          Veh    Ex4                          Veh    Ex4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B495339D-2FFB-A947-9872-89CC1E3E829A}"/>
              </a:ext>
            </a:extLst>
          </p:cNvPr>
          <p:cNvSpPr txBox="1"/>
          <p:nvPr/>
        </p:nvSpPr>
        <p:spPr>
          <a:xfrm>
            <a:off x="857019" y="6907884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E786F3EB-F6A0-484E-948F-BE8FCED0CB70}"/>
              </a:ext>
            </a:extLst>
          </p:cNvPr>
          <p:cNvSpPr txBox="1"/>
          <p:nvPr/>
        </p:nvSpPr>
        <p:spPr>
          <a:xfrm>
            <a:off x="1822824" y="6989157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3F2815AF-ADA7-C643-88C8-D4D124BC9101}"/>
              </a:ext>
            </a:extLst>
          </p:cNvPr>
          <p:cNvSpPr txBox="1"/>
          <p:nvPr/>
        </p:nvSpPr>
        <p:spPr>
          <a:xfrm>
            <a:off x="2804335" y="7038037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631A5B5D-0AE3-0043-B69C-B3A2C8C9F31F}"/>
              </a:ext>
            </a:extLst>
          </p:cNvPr>
          <p:cNvSpPr txBox="1"/>
          <p:nvPr/>
        </p:nvSpPr>
        <p:spPr>
          <a:xfrm>
            <a:off x="3790035" y="6699895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n.s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2FED4A-749A-A042-BC1A-5EA14C6A2D1B}"/>
              </a:ext>
            </a:extLst>
          </p:cNvPr>
          <p:cNvSpPr txBox="1"/>
          <p:nvPr/>
        </p:nvSpPr>
        <p:spPr>
          <a:xfrm>
            <a:off x="178919" y="3751050"/>
            <a:ext cx="32367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C.                                          D.                                      E.                                         </a:t>
            </a:r>
          </a:p>
          <a:p>
            <a:r>
              <a:rPr lang="en-US" sz="800" dirty="0"/>
              <a:t>      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C9F3B376-2773-1A44-9DD6-27934C98BA81}"/>
              </a:ext>
            </a:extLst>
          </p:cNvPr>
          <p:cNvSpPr txBox="1"/>
          <p:nvPr/>
        </p:nvSpPr>
        <p:spPr>
          <a:xfrm>
            <a:off x="179675" y="4776836"/>
            <a:ext cx="22317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F.                                          G.                                      H.</a:t>
            </a:r>
          </a:p>
          <a:p>
            <a:r>
              <a:rPr lang="en-US" sz="800" dirty="0"/>
              <a:t>      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0D312F64-C12C-FC43-BCD9-CF28BEED5466}"/>
              </a:ext>
            </a:extLst>
          </p:cNvPr>
          <p:cNvSpPr txBox="1"/>
          <p:nvPr/>
        </p:nvSpPr>
        <p:spPr>
          <a:xfrm>
            <a:off x="176753" y="6325306"/>
            <a:ext cx="40799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I.                                          J                                       K.                                         L.                                           </a:t>
            </a:r>
          </a:p>
          <a:p>
            <a:r>
              <a:rPr lang="en-US" sz="800" dirty="0"/>
              <a:t>     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E8793FC-AC0E-8F4E-8C75-EC732981B9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51" y="462437"/>
            <a:ext cx="5359400" cy="1066800"/>
          </a:xfrm>
          <a:prstGeom prst="rect">
            <a:avLst/>
          </a:prstGeom>
        </p:spPr>
      </p:pic>
      <p:sp>
        <p:nvSpPr>
          <p:cNvPr id="41" name="Rounded Rectangle 40">
            <a:extLst>
              <a:ext uri="{FF2B5EF4-FFF2-40B4-BE49-F238E27FC236}">
                <a16:creationId xmlns:a16="http://schemas.microsoft.com/office/drawing/2014/main" id="{B133F343-4E63-D94E-9FD2-923632406048}"/>
              </a:ext>
            </a:extLst>
          </p:cNvPr>
          <p:cNvSpPr/>
          <p:nvPr/>
        </p:nvSpPr>
        <p:spPr>
          <a:xfrm>
            <a:off x="152400" y="1656320"/>
            <a:ext cx="3185519" cy="1732564"/>
          </a:xfrm>
          <a:prstGeom prst="roundRect">
            <a:avLst/>
          </a:prstGeom>
          <a:noFill/>
          <a:ln w="381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B69D578-A9EF-AE40-8E4D-8411A13FC0DC}"/>
              </a:ext>
            </a:extLst>
          </p:cNvPr>
          <p:cNvSpPr txBox="1"/>
          <p:nvPr/>
        </p:nvSpPr>
        <p:spPr>
          <a:xfrm rot="16200000">
            <a:off x="-164064" y="2206522"/>
            <a:ext cx="10762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Attack </a:t>
            </a:r>
          </a:p>
          <a:p>
            <a:r>
              <a:rPr lang="en-US" sz="800">
                <a:cs typeface="Arial" panose="020B0604020202020204" pitchFamily="34" charset="0"/>
              </a:rPr>
              <a:t>latency (sec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819CE6A-4F95-5749-9936-78AFEA53844C}"/>
              </a:ext>
            </a:extLst>
          </p:cNvPr>
          <p:cNvSpPr txBox="1"/>
          <p:nvPr/>
        </p:nvSpPr>
        <p:spPr>
          <a:xfrm rot="16200000">
            <a:off x="1619185" y="2038224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C1413D0-884B-AB4A-8033-2E55D54F531D}"/>
              </a:ext>
            </a:extLst>
          </p:cNvPr>
          <p:cNvSpPr txBox="1"/>
          <p:nvPr/>
        </p:nvSpPr>
        <p:spPr>
          <a:xfrm>
            <a:off x="1070177" y="3105668"/>
            <a:ext cx="755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cs typeface="Arial" panose="020B0604020202020204" pitchFamily="34" charset="0"/>
              </a:rPr>
              <a:t>  Training day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8F990F73-3A54-8948-A414-72CFBAE03883}"/>
              </a:ext>
            </a:extLst>
          </p:cNvPr>
          <p:cNvGrpSpPr/>
          <p:nvPr/>
        </p:nvGrpSpPr>
        <p:grpSpPr>
          <a:xfrm>
            <a:off x="794627" y="2585987"/>
            <a:ext cx="455323" cy="338554"/>
            <a:chOff x="3768945" y="2042952"/>
            <a:chExt cx="455323" cy="338554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B6DB621-0A83-DC47-BDD1-C8347A32707B}"/>
                </a:ext>
              </a:extLst>
            </p:cNvPr>
            <p:cNvSpPr txBox="1"/>
            <p:nvPr/>
          </p:nvSpPr>
          <p:spPr>
            <a:xfrm>
              <a:off x="3771545" y="2042952"/>
              <a:ext cx="45272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cs typeface="Arial" panose="020B0604020202020204" pitchFamily="34" charset="0"/>
                </a:rPr>
                <a:t>Ex4</a:t>
              </a:r>
            </a:p>
            <a:p>
              <a:r>
                <a:rPr lang="en-US" sz="800">
                  <a:cs typeface="Arial" panose="020B0604020202020204" pitchFamily="34" charset="0"/>
                </a:rPr>
                <a:t>Veh    </a:t>
              </a:r>
            </a:p>
          </p:txBody>
        </p:sp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43AA75D4-DDA8-1F45-B78F-2EB3D6A3F454}"/>
                </a:ext>
              </a:extLst>
            </p:cNvPr>
            <p:cNvSpPr/>
            <p:nvPr/>
          </p:nvSpPr>
          <p:spPr>
            <a:xfrm>
              <a:off x="3768945" y="2129139"/>
              <a:ext cx="54000" cy="55604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D2E9379E-8645-B346-B9FB-A61F920AC9A2}"/>
                </a:ext>
              </a:extLst>
            </p:cNvPr>
            <p:cNvSpPr/>
            <p:nvPr/>
          </p:nvSpPr>
          <p:spPr>
            <a:xfrm>
              <a:off x="3774345" y="2250434"/>
              <a:ext cx="43200" cy="43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49" name="Picture 48">
            <a:extLst>
              <a:ext uri="{FF2B5EF4-FFF2-40B4-BE49-F238E27FC236}">
                <a16:creationId xmlns:a16="http://schemas.microsoft.com/office/drawing/2014/main" id="{CE06DA69-8178-3244-81DB-302114FFA3D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9151" y="3842881"/>
            <a:ext cx="693027" cy="9000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8A44599F-68AA-F140-BA09-5F3E37A7348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456" y="4896409"/>
            <a:ext cx="657804" cy="9000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6F26A64B-9912-2F4C-98CF-72EFD887544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8200" y="4896409"/>
            <a:ext cx="728250" cy="9000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EAA1F22F-BD8F-D44B-B0D9-81ACFA8D45F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675" y="3842881"/>
            <a:ext cx="728250" cy="9000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2A2BF394-183D-8641-8CC8-669167DCBCC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06" y="3842881"/>
            <a:ext cx="728250" cy="9000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FC949FF9-2A8C-B74A-9ED0-690A1F56818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978" y="4896409"/>
            <a:ext cx="728250" cy="9000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F44D9797-37A6-2E4A-9614-A93E14A6EE1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471" y="6587271"/>
            <a:ext cx="728250" cy="9000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2D69C5F8-85D4-A04F-A6E4-3CFF8EBB9F7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9584" y="6587271"/>
            <a:ext cx="657804" cy="900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EFFAD4C3-A62A-C847-8277-180D1D5B394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3122" y="6587271"/>
            <a:ext cx="728250" cy="9000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A3E71215-38F0-5C44-BDDD-59852262CEF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661" y="6587271"/>
            <a:ext cx="728250" cy="90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58596DC-A44C-D940-B082-6BC6E166AC4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603" y="1955866"/>
            <a:ext cx="1937052" cy="1116000"/>
          </a:xfrm>
          <a:prstGeom prst="rect">
            <a:avLst/>
          </a:prstGeom>
        </p:spPr>
      </p:pic>
      <p:grpSp>
        <p:nvGrpSpPr>
          <p:cNvPr id="60" name="Group 59">
            <a:extLst>
              <a:ext uri="{FF2B5EF4-FFF2-40B4-BE49-F238E27FC236}">
                <a16:creationId xmlns:a16="http://schemas.microsoft.com/office/drawing/2014/main" id="{F74BCE07-C889-4444-80D2-239E62D21061}"/>
              </a:ext>
            </a:extLst>
          </p:cNvPr>
          <p:cNvGrpSpPr/>
          <p:nvPr/>
        </p:nvGrpSpPr>
        <p:grpSpPr>
          <a:xfrm>
            <a:off x="136275" y="741622"/>
            <a:ext cx="257577" cy="264577"/>
            <a:chOff x="5236330" y="2623412"/>
            <a:chExt cx="257577" cy="264577"/>
          </a:xfrm>
        </p:grpSpPr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58DF5282-81AD-E847-9ED9-6DE1A4CBACAD}"/>
                </a:ext>
              </a:extLst>
            </p:cNvPr>
            <p:cNvSpPr/>
            <p:nvPr/>
          </p:nvSpPr>
          <p:spPr>
            <a:xfrm>
              <a:off x="5236330" y="2623412"/>
              <a:ext cx="257577" cy="2645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673F257-0208-C94F-874E-69BF6AE73222}"/>
                </a:ext>
              </a:extLst>
            </p:cNvPr>
            <p:cNvSpPr txBox="1"/>
            <p:nvPr/>
          </p:nvSpPr>
          <p:spPr>
            <a:xfrm>
              <a:off x="5243998" y="264139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#</a:t>
              </a:r>
            </a:p>
          </p:txBody>
        </p:sp>
      </p:grpSp>
      <p:sp>
        <p:nvSpPr>
          <p:cNvPr id="67" name="Right Bracket 66">
            <a:extLst>
              <a:ext uri="{FF2B5EF4-FFF2-40B4-BE49-F238E27FC236}">
                <a16:creationId xmlns:a16="http://schemas.microsoft.com/office/drawing/2014/main" id="{645D312F-130B-7B44-95EE-E25DA49408D2}"/>
              </a:ext>
            </a:extLst>
          </p:cNvPr>
          <p:cNvSpPr/>
          <p:nvPr/>
        </p:nvSpPr>
        <p:spPr>
          <a:xfrm>
            <a:off x="2305615" y="2462351"/>
            <a:ext cx="49554" cy="25200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SE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97122F6-DBC6-5145-A832-DEB82F66786D}"/>
              </a:ext>
            </a:extLst>
          </p:cNvPr>
          <p:cNvSpPr txBox="1"/>
          <p:nvPr/>
        </p:nvSpPr>
        <p:spPr>
          <a:xfrm rot="16200000">
            <a:off x="2326558" y="247670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/>
              <a:t>*</a:t>
            </a:r>
            <a:endParaRPr lang="en-SE" sz="8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46BCB1F-0E82-3C44-8B83-AF574172C07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646609" y="1976659"/>
            <a:ext cx="691310" cy="997200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5339A073-B5AE-C14D-BE0A-4D1FDEDD5234}"/>
              </a:ext>
            </a:extLst>
          </p:cNvPr>
          <p:cNvSpPr txBox="1"/>
          <p:nvPr/>
        </p:nvSpPr>
        <p:spPr>
          <a:xfrm>
            <a:off x="187272" y="1793522"/>
            <a:ext cx="34483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A.                                                                                                  B.                                      </a:t>
            </a:r>
          </a:p>
          <a:p>
            <a:r>
              <a:rPr lang="en-US" sz="800" dirty="0"/>
              <a:t>     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7691223-CC0E-C346-BA75-80473CFC4094}"/>
              </a:ext>
            </a:extLst>
          </p:cNvPr>
          <p:cNvSpPr txBox="1"/>
          <p:nvPr/>
        </p:nvSpPr>
        <p:spPr>
          <a:xfrm rot="16200000">
            <a:off x="2029232" y="2331636"/>
            <a:ext cx="10762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Area under the curve</a:t>
            </a:r>
          </a:p>
        </p:txBody>
      </p:sp>
    </p:spTree>
    <p:extLst>
      <p:ext uri="{BB962C8B-B14F-4D97-AF65-F5344CB8AC3E}">
        <p14:creationId xmlns:p14="http://schemas.microsoft.com/office/powerpoint/2010/main" val="37692685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E1B618B5-2541-4359-A94C-3040D317F408}"/>
              </a:ext>
            </a:extLst>
          </p:cNvPr>
          <p:cNvSpPr/>
          <p:nvPr/>
        </p:nvSpPr>
        <p:spPr>
          <a:xfrm>
            <a:off x="154640" y="0"/>
            <a:ext cx="5560359" cy="4667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100" b="1" dirty="0">
                <a:ea typeface="Calibri" panose="020F0502020204030204" pitchFamily="34" charset="0"/>
                <a:cs typeface="Arial" panose="020B0604020202020204" pitchFamily="34" charset="0"/>
              </a:rPr>
              <a:t>Supplementary Figure 1. In male mice, repeated Ex4 treatment reduces attack behaviors during training</a:t>
            </a: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Panel A illustrates the outline of the experiment, where mice were randomized (#) to exendin-4 (Ex4; 2.4 </a:t>
            </a: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µg/kg, IP, n=8)</a:t>
            </a: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 or vehicle (</a:t>
            </a:r>
            <a:r>
              <a:rPr lang="en-US" sz="1100" dirty="0" err="1">
                <a:ea typeface="Calibri" panose="020F0502020204030204" pitchFamily="34" charset="0"/>
                <a:cs typeface="Arial" panose="020B0604020202020204" pitchFamily="34" charset="0"/>
              </a:rPr>
              <a:t>Veh</a:t>
            </a: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, IP, n=8) treatment prior to exposure to the resident intruder test. Thereafter, the mice received treatment during training (day 1-6, Panel B) and test day (day 7, Panel C-D). During training the latency to attack was recorded, and at the test day, aggressive behaviors (attack and threat) and non-aggressive behaviors (social and non-social) were recorded for 10 minutes. </a:t>
            </a: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(A) Ex4 increases the latency (treatment F(1,14)=8.78, P=0.0103, time F(5,70)=3.87, P=0.0038, interaction F(5,70)=1.77, P=0.1306; n=8 per group) to attack during the entire training period (day 1-6). The Bonferroni post-hoc test showed that the latency to attack is higher in Ex4 compared to vehicle treated mice at day 4 (P=0.0019). (B) This is further evident as the area under the curve of attack latency is higher in Ex4 compared to vehicle treated mice (t(14)=2.37, P=0.0321). </a:t>
            </a: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Panel C demonstrates that there at test day is no differences in (C) attack duration (t(14)=0.27, P=0.7940), (D) attack frequency (t(14)=0.87, P=0.3972), (E) attack latency (t(14)=0.69, P=0.5040), (F) threat duration (t(14)=0.76, P=0.4594), (G) threat frequency (t(14)=0.47, P=0.6440) or (H) threat latency (t(14)=0.40, P=0.6944) between Ex4 and vehicle treatment. As the effect on attack behaviors during training no longer is present, there might be a tolerance development towards Ex4 when it comes to aggressive behaviors. </a:t>
            </a: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Panel D reveals that Ex4 does not effect the (I) social behaviors duration (t(14)=0.54, P=0.5980), (J) social behaviors frequency (t(14)=0.29, P=0.7790), (K) social behavior latency (t(14)=1.15, P=0.2707) or (L) non-social behavior duration (t(14)=0.28, P=0.7832).</a:t>
            </a: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Data are presented as Mean ± SEM, ** P&lt;0.01, *P&lt;0.05, </a:t>
            </a:r>
            <a:r>
              <a:rPr lang="en-US" sz="1100" dirty="0" err="1">
                <a:ea typeface="Calibri" panose="020F0502020204030204" pitchFamily="34" charset="0"/>
                <a:cs typeface="Arial" panose="020B0604020202020204" pitchFamily="34" charset="0"/>
              </a:rPr>
              <a:t>n.s</a:t>
            </a: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.=non-significant. </a:t>
            </a:r>
          </a:p>
        </p:txBody>
      </p:sp>
    </p:spTree>
    <p:extLst>
      <p:ext uri="{BB962C8B-B14F-4D97-AF65-F5344CB8AC3E}">
        <p14:creationId xmlns:p14="http://schemas.microsoft.com/office/powerpoint/2010/main" val="2040495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>
            <a:extLst>
              <a:ext uri="{FF2B5EF4-FFF2-40B4-BE49-F238E27FC236}">
                <a16:creationId xmlns:a16="http://schemas.microsoft.com/office/drawing/2014/main" id="{50FD1990-0D8B-D04F-A070-6DAF4447FDDB}"/>
              </a:ext>
            </a:extLst>
          </p:cNvPr>
          <p:cNvSpPr txBox="1"/>
          <p:nvPr/>
        </p:nvSpPr>
        <p:spPr>
          <a:xfrm>
            <a:off x="45809" y="-4243"/>
            <a:ext cx="1682768" cy="17235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Supplementary figure 2</a:t>
            </a: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200" b="1" dirty="0">
              <a:cs typeface="Arial" panose="020B0604020202020204" pitchFamily="34" charset="0"/>
            </a:endParaRPr>
          </a:p>
          <a:p>
            <a:endParaRPr lang="en-US" sz="1000" b="1" dirty="0">
              <a:cs typeface="Arial" panose="020B0604020202020204" pitchFamily="34" charset="0"/>
            </a:endParaRPr>
          </a:p>
        </p:txBody>
      </p:sp>
      <p:sp>
        <p:nvSpPr>
          <p:cNvPr id="204" name="Rounded Rectangle 203">
            <a:extLst>
              <a:ext uri="{FF2B5EF4-FFF2-40B4-BE49-F238E27FC236}">
                <a16:creationId xmlns:a16="http://schemas.microsoft.com/office/drawing/2014/main" id="{D07A04E4-DE3C-1943-8841-A7058B804106}"/>
              </a:ext>
            </a:extLst>
          </p:cNvPr>
          <p:cNvSpPr/>
          <p:nvPr/>
        </p:nvSpPr>
        <p:spPr>
          <a:xfrm>
            <a:off x="149423" y="241883"/>
            <a:ext cx="3487858" cy="4711117"/>
          </a:xfrm>
          <a:prstGeom prst="roundRect">
            <a:avLst/>
          </a:prstGeom>
          <a:noFill/>
          <a:ln w="38100"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C821B3-4FC7-E546-8787-E29CCBC83F61}"/>
              </a:ext>
            </a:extLst>
          </p:cNvPr>
          <p:cNvSpPr txBox="1"/>
          <p:nvPr/>
        </p:nvSpPr>
        <p:spPr>
          <a:xfrm>
            <a:off x="316356" y="325024"/>
            <a:ext cx="2026517" cy="31700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lphaUcPeriod"/>
            </a:pPr>
            <a:r>
              <a:rPr lang="en-SE" sz="800" dirty="0"/>
              <a:t>                                                             B.</a:t>
            </a:r>
          </a:p>
          <a:p>
            <a:r>
              <a:rPr lang="en-SE" sz="800" dirty="0"/>
              <a:t>    </a:t>
            </a:r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r>
              <a:rPr lang="en-SE" sz="800" dirty="0"/>
              <a:t>C.                                                                         D.</a:t>
            </a:r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endParaRPr lang="en-SE" sz="800" dirty="0"/>
          </a:p>
          <a:p>
            <a:r>
              <a:rPr lang="en-SE" sz="800" dirty="0"/>
              <a:t>E.                                                                         F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0727D2F-191A-0344-9ABA-9919A6F065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1195" y="533037"/>
            <a:ext cx="1608232" cy="11862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45A2C65-77B3-EB49-A993-59E29C252DB7}"/>
              </a:ext>
            </a:extLst>
          </p:cNvPr>
          <p:cNvSpPr txBox="1"/>
          <p:nvPr/>
        </p:nvSpPr>
        <p:spPr>
          <a:xfrm>
            <a:off x="325324" y="1534640"/>
            <a:ext cx="8899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- 0.2 mm from bregm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B88030F-6538-9245-9AD3-D1B611D44E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5288" y="1966997"/>
            <a:ext cx="1598886" cy="118627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EB0C774-1EEE-584F-9AB1-37E506ED32FD}"/>
              </a:ext>
            </a:extLst>
          </p:cNvPr>
          <p:cNvSpPr txBox="1"/>
          <p:nvPr/>
        </p:nvSpPr>
        <p:spPr>
          <a:xfrm>
            <a:off x="325324" y="2968601"/>
            <a:ext cx="9044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+0.2 mm from bregma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84B2464-DC5F-7047-BC82-A4B044BB7D7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5289" y="3431014"/>
            <a:ext cx="1592310" cy="118627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703F365-8B61-5F4B-9F3F-A372970FB9C4}"/>
              </a:ext>
            </a:extLst>
          </p:cNvPr>
          <p:cNvSpPr txBox="1"/>
          <p:nvPr/>
        </p:nvSpPr>
        <p:spPr>
          <a:xfrm>
            <a:off x="325324" y="4434907"/>
            <a:ext cx="87075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-0.2 mm from bregma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0DFDFB2-2885-4144-A90F-E3F26A9971C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4373" y="560457"/>
            <a:ext cx="1179386" cy="108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74D4702-085D-6D4C-B129-536159B11FE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4857" y="2006311"/>
            <a:ext cx="1139630" cy="108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E099AC8-26C2-1643-B0C2-A42C444BF3C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0837" y="3475368"/>
            <a:ext cx="1139625" cy="10800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15B16214-9FE4-9740-8C04-2304B649FE9F}"/>
              </a:ext>
            </a:extLst>
          </p:cNvPr>
          <p:cNvSpPr txBox="1"/>
          <p:nvPr/>
        </p:nvSpPr>
        <p:spPr>
          <a:xfrm rot="16200000">
            <a:off x="1677452" y="929393"/>
            <a:ext cx="953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FOS (counts/slide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C11F7BB-0D87-D248-8451-AE7B1C251B92}"/>
              </a:ext>
            </a:extLst>
          </p:cNvPr>
          <p:cNvSpPr txBox="1"/>
          <p:nvPr/>
        </p:nvSpPr>
        <p:spPr>
          <a:xfrm rot="16200000">
            <a:off x="1617542" y="2389796"/>
            <a:ext cx="1080000" cy="218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FOS (counts/slide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DCB82A5-AA22-6442-A30B-01F37ADCFC3B}"/>
              </a:ext>
            </a:extLst>
          </p:cNvPr>
          <p:cNvSpPr txBox="1"/>
          <p:nvPr/>
        </p:nvSpPr>
        <p:spPr>
          <a:xfrm rot="16200000">
            <a:off x="1641242" y="3938522"/>
            <a:ext cx="1105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FOS (counts/slide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C38FAD4-EC7C-A140-A7C5-E6EE837487E6}"/>
              </a:ext>
            </a:extLst>
          </p:cNvPr>
          <p:cNvSpPr txBox="1"/>
          <p:nvPr/>
        </p:nvSpPr>
        <p:spPr>
          <a:xfrm>
            <a:off x="2453112" y="1575894"/>
            <a:ext cx="842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  </a:t>
            </a:r>
            <a:r>
              <a:rPr lang="en-US" sz="800" dirty="0" err="1">
                <a:cs typeface="Arial" panose="020B0604020202020204" pitchFamily="34" charset="0"/>
              </a:rPr>
              <a:t>Veh</a:t>
            </a:r>
            <a:r>
              <a:rPr lang="en-US" sz="800" dirty="0">
                <a:cs typeface="Arial" panose="020B0604020202020204" pitchFamily="34" charset="0"/>
              </a:rPr>
              <a:t>            Ex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6A856BA-2387-964A-BB47-61BBD29745D2}"/>
              </a:ext>
            </a:extLst>
          </p:cNvPr>
          <p:cNvSpPr txBox="1"/>
          <p:nvPr/>
        </p:nvSpPr>
        <p:spPr>
          <a:xfrm>
            <a:off x="2453112" y="3015887"/>
            <a:ext cx="842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  </a:t>
            </a:r>
            <a:r>
              <a:rPr lang="en-US" sz="800" dirty="0" err="1">
                <a:cs typeface="Arial" panose="020B0604020202020204" pitchFamily="34" charset="0"/>
              </a:rPr>
              <a:t>Veh</a:t>
            </a:r>
            <a:r>
              <a:rPr lang="en-US" sz="800" dirty="0">
                <a:cs typeface="Arial" panose="020B0604020202020204" pitchFamily="34" charset="0"/>
              </a:rPr>
              <a:t>            Ex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37021FE-F8F7-6E47-99AC-FC2DA99AEB18}"/>
              </a:ext>
            </a:extLst>
          </p:cNvPr>
          <p:cNvSpPr txBox="1"/>
          <p:nvPr/>
        </p:nvSpPr>
        <p:spPr>
          <a:xfrm>
            <a:off x="2453112" y="4482419"/>
            <a:ext cx="842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  </a:t>
            </a:r>
            <a:r>
              <a:rPr lang="en-US" sz="800" dirty="0" err="1">
                <a:cs typeface="Arial" panose="020B0604020202020204" pitchFamily="34" charset="0"/>
              </a:rPr>
              <a:t>Veh</a:t>
            </a:r>
            <a:r>
              <a:rPr lang="en-US" sz="800" dirty="0">
                <a:cs typeface="Arial" panose="020B0604020202020204" pitchFamily="34" charset="0"/>
              </a:rPr>
              <a:t>            Ex4</a:t>
            </a:r>
          </a:p>
        </p:txBody>
      </p:sp>
    </p:spTree>
    <p:extLst>
      <p:ext uri="{BB962C8B-B14F-4D97-AF65-F5344CB8AC3E}">
        <p14:creationId xmlns:p14="http://schemas.microsoft.com/office/powerpoint/2010/main" val="31150633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E1B618B5-2541-4359-A94C-3040D317F408}"/>
              </a:ext>
            </a:extLst>
          </p:cNvPr>
          <p:cNvSpPr/>
          <p:nvPr/>
        </p:nvSpPr>
        <p:spPr>
          <a:xfrm>
            <a:off x="154640" y="0"/>
            <a:ext cx="5560359" cy="26007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100" b="1" dirty="0">
                <a:ea typeface="Calibri" panose="020F0502020204030204" pitchFamily="34" charset="0"/>
                <a:cs typeface="Arial" panose="020B0604020202020204" pitchFamily="34" charset="0"/>
              </a:rPr>
              <a:t>Supplementary Figure 2. In male mice, a low dose of Ex4 does not alter number of FOS immunoreactive cells in aggression-related brain regions</a:t>
            </a: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Count of cells positive for FOS immunoreactivity, (A) as represented by one picture of paraventricular thalamus (PVT), (B) reveal no differences between treatments (P=0.8801) in this area. (C) Representative picture of bed nucleus of the stria terminalis (BNST), where </a:t>
            </a:r>
            <a:r>
              <a:rPr lang="en-US" sz="1100">
                <a:ea typeface="Calibri" panose="020F0502020204030204" pitchFamily="34" charset="0"/>
                <a:cs typeface="Arial" panose="020B0604020202020204" pitchFamily="34" charset="0"/>
              </a:rPr>
              <a:t>the FOS </a:t>
            </a: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immunoreactivity was counted, (D) show no treatment effect on FOS immunoreactivity (P=0.6583). Furthermore, (E) as represented by a picture of FOS immunoreactivity of medial preoptic area (MPOA) (F) there are no FOS immunoreactivity differences between treatment groups (P=0.5977). </a:t>
            </a: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For each area, vehicle (</a:t>
            </a:r>
            <a:r>
              <a:rPr lang="en-US" sz="1100" dirty="0" err="1">
                <a:ea typeface="Calibri" panose="020F0502020204030204" pitchFamily="34" charset="0"/>
                <a:cs typeface="Arial" panose="020B0604020202020204" pitchFamily="34" charset="0"/>
              </a:rPr>
              <a:t>Veh</a:t>
            </a: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; n=3, and 2-4 slices from each animal) treatment is compared to a low dose of exendin-4 (Ex4; n=3, and 2-4 slices from each animal). </a:t>
            </a:r>
            <a:r>
              <a:rPr lang="en-US" sz="1100" dirty="0"/>
              <a:t>Stria medullaris (SM), third ventricle (3V), anterior </a:t>
            </a:r>
            <a:r>
              <a:rPr lang="en-US" sz="1100" dirty="0" err="1"/>
              <a:t>comissure</a:t>
            </a:r>
            <a:r>
              <a:rPr lang="en-US" sz="1100" dirty="0"/>
              <a:t> (AC), lateral ventricle (LV)</a:t>
            </a:r>
            <a:endParaRPr lang="en-US" sz="1100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100" dirty="0">
                <a:ea typeface="Calibri" panose="020F0502020204030204" pitchFamily="34" charset="0"/>
                <a:cs typeface="Arial" panose="020B0604020202020204" pitchFamily="34" charset="0"/>
              </a:rPr>
              <a:t>Data are presented as Mean ± SEM</a:t>
            </a:r>
          </a:p>
        </p:txBody>
      </p:sp>
    </p:spTree>
    <p:extLst>
      <p:ext uri="{BB962C8B-B14F-4D97-AF65-F5344CB8AC3E}">
        <p14:creationId xmlns:p14="http://schemas.microsoft.com/office/powerpoint/2010/main" val="552432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31</TotalTime>
  <Words>958</Words>
  <Application>Microsoft Office PowerPoint</Application>
  <PresentationFormat>A4 Paper (210x297 mm)</PresentationFormat>
  <Paragraphs>143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per Vestlund</dc:creator>
  <cp:lastModifiedBy>Jesper Vestlund</cp:lastModifiedBy>
  <cp:revision>545</cp:revision>
  <cp:lastPrinted>2019-12-16T15:44:43Z</cp:lastPrinted>
  <dcterms:created xsi:type="dcterms:W3CDTF">2017-08-23T09:54:16Z</dcterms:created>
  <dcterms:modified xsi:type="dcterms:W3CDTF">2022-04-30T05:16:49Z</dcterms:modified>
</cp:coreProperties>
</file>